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461" y="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8472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4440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715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0000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2590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8573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903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6841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8192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012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630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E42EB-9793-4035-8455-D92B10A01431}" type="datetimeFigureOut">
              <a:rPr kumimoji="1" lang="ja-JP" altLang="en-US" smtClean="0"/>
              <a:t>2020/8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CB1EC-7F27-4814-A50C-9E8F0FF02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806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827584" y="908720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5496" y="56818"/>
            <a:ext cx="91171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endParaRPr lang="en-US" altLang="ja-JP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1353690" y="939498"/>
            <a:ext cx="429843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nnel 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lot for the hospital mortality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6516216" y="5733256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R</a:t>
            </a:r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risk ratio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0" y="1524000"/>
            <a:ext cx="5715000" cy="3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8326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827584" y="908720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5496" y="56818"/>
            <a:ext cx="91171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endParaRPr lang="en-US" altLang="ja-JP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1353690" y="939498"/>
            <a:ext cx="74667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nnel 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lot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or the attainment of target plasma concentration 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6516216" y="5733256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R</a:t>
            </a:r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risk ratio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0" y="1524000"/>
            <a:ext cx="5715000" cy="3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411162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827584" y="908720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5496" y="56818"/>
            <a:ext cx="91171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endParaRPr lang="en-US" altLang="ja-JP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1353690" y="939498"/>
            <a:ext cx="393839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nnel 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lot for the clinical cure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6516216" y="5733256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R</a:t>
            </a:r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risk ratio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0" y="1524000"/>
            <a:ext cx="5715000" cy="3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411162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827584" y="908720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5496" y="56818"/>
            <a:ext cx="91171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ja-JP" sz="200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altLang="ja-JP" sz="200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endParaRPr lang="en-US" altLang="ja-JP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1353690" y="939498"/>
            <a:ext cx="372236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nnel 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lot for the adverse event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6516216" y="5733256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R</a:t>
            </a:r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risk ratio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0" y="1524000"/>
            <a:ext cx="5715000" cy="3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411162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827584" y="908720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5496" y="56818"/>
            <a:ext cx="91171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le 2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ja-JP" sz="2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1353690" y="939498"/>
            <a:ext cx="696272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nnel 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lot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or the occurrence of antibiotic-resistant bacteria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6516216" y="5733256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R</a:t>
            </a:r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risk ratio</a:t>
            </a:r>
            <a:endParaRPr lang="ja-JP" altLang="ja-JP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0" y="1524000"/>
            <a:ext cx="5715000" cy="3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41116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90</Words>
  <Application>Microsoft Office PowerPoint</Application>
  <PresentationFormat>画面に合わせる (4:3)</PresentationFormat>
  <Paragraphs>20</Paragraphs>
  <Slides>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救急医療講座Z０２</dc:creator>
  <cp:lastModifiedBy>救急医療講座Z０２</cp:lastModifiedBy>
  <cp:revision>14</cp:revision>
  <dcterms:created xsi:type="dcterms:W3CDTF">2020-02-15T15:04:02Z</dcterms:created>
  <dcterms:modified xsi:type="dcterms:W3CDTF">2020-08-27T02:28:07Z</dcterms:modified>
</cp:coreProperties>
</file>